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</p:sldIdLst>
  <p:sldSz cx="12192000" cy="6858000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59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E521AAF-D0A5-471B-AB2A-4B878700C9E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668D7D80-3A21-46F4-ABA4-C207FCDE53F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5B04063-0143-4401-AF85-9C746A16E1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19A0426-B7EE-4562-A266-26F300EC84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71E37DD-A18A-42BC-A267-20A3A8931F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9958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7161C8A-2A7D-42D4-A118-0E161E3838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52A9ED7-80C3-4E28-B9A4-C1BC85840C6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B42864C-C2E0-4A29-B3D5-D9564E9C63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169F4D1-70BB-4F7D-BC76-3E8F8CFCD6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8D6FAA4-7D49-4741-A9F6-0A9935D068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30604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EED50870-3898-4BDB-9347-AFD44722903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AC44191-EED9-4FEF-B8F8-11A93013036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F19FBD3-37B3-4037-9A4B-247BE8328B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1512FB6-C19C-42EF-8A20-76671BFE95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803CAF1-A8C2-4BFC-82B1-F414B67978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40204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DAC1358-C278-486D-96A7-D7EE26781E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B596B36-DC6C-4128-81F4-B8CC924323A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6106111-F22D-4E93-A27C-1718BE0D1B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DFF742F-7B50-4ED5-9FAA-4B470C0750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F43246A-876F-4FA2-8B81-0396A14D45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11703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7C9FE43-D367-4BF1-9199-F3CAE9F19D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6429400-4781-49AB-B003-F9901C3564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F4357CC-B8B8-4DD9-AC1F-57D3E3E2C2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5E35705-77CF-44DE-9734-F1AD9868DE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4FE17C0-0132-4DF8-A152-A482BA16FF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77516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ABC4F63-A95C-4033-87B1-5AA8096BEA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1D1C2DD-ECE2-4E52-A293-17936AEF51C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56822AF-1F00-4EC6-AE9C-F7C3337BD6C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3FB725F-99DA-4F9D-ACF6-99707CE02C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87D1B0E-A8E6-4B14-A7BE-C90A670C51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9E4A7EB-713A-48B1-A22D-27465DDB3B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26040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C50D42C-811D-4762-AE25-D3AF02AAEC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FC1844C-D363-4265-9552-2E8A188A35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03EEEC3-6FF1-4595-BCC0-6DF7F171138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537C7D48-D5BA-499B-96DA-FF6EF24061D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9DA08F2B-20F9-4FC2-9B4E-1B22F35A1D1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8B20E279-CD23-4EF9-A3D8-3B8D911A7C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07A81EB6-909A-455F-A59E-70E3A871B0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C266D316-4F8D-456E-985A-06BAF752E3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60226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4575DAC-2DD0-4008-B087-E374FFA3E0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9C117E92-F529-4843-BFFA-8FBB65A215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48A723E4-535C-4B92-8BB4-52AE3C8FA4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F17923EC-C2CC-457C-9819-6BCFA82BF0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78556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37EC8F30-7F17-4408-BD44-A4E27E4AF9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852BB490-E49F-45E1-9F0C-2532D6F807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B0D3576E-DB4A-4570-BF0D-704CA83176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75443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E8AB86E-44CE-4EFD-A5CD-CC8E746B29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407EF18-F398-4163-ABE5-3503D99BC3E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C979A3C-23BA-4E66-A64A-F12F1BC682B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2986307-833A-4E86-AC7B-FCC5C6B392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C7E7E5D-048C-47AE-83F4-EF72666433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27EC1F4-8E73-4482-AB71-45F243332C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56449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5B84D41-B384-4320-9E37-871EB74527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D0988792-D6A9-4C60-BA5C-EC95425DEFA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C237948-C344-4DD1-A290-9B4F12367C1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46CA909-7BFC-4C95-881A-20248B2255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2C32CB3-4FA8-423E-8579-D6C8E8994A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25325EF-82A4-450C-BE8A-25C9E318CC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75578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BB5F9837-67C5-4C40-993C-F02DBA4D26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5F5FDC4-8FCA-49ED-8D4A-C6E156640BC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75AFEDC-718E-45EE-B5C0-A85AC523FBF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EE4E78E-D98B-4635-B2C6-720BB4F766A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F5CF415-1A74-4B42-9FC0-5B91978A791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88587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64149916"/>
              </p:ext>
            </p:extLst>
          </p:nvPr>
        </p:nvGraphicFramePr>
        <p:xfrm>
          <a:off x="157479" y="325960"/>
          <a:ext cx="7632173" cy="2346960"/>
        </p:xfrm>
        <a:graphic>
          <a:graphicData uri="http://schemas.openxmlformats.org/drawingml/2006/table">
            <a:tbl>
              <a:tblPr firstRow="1" firstCol="1" bandRow="1"/>
              <a:tblGrid>
                <a:gridCol w="1429437">
                  <a:extLst>
                    <a:ext uri="{9D8B030D-6E8A-4147-A177-3AD203B41FA5}">
                      <a16:colId xmlns:a16="http://schemas.microsoft.com/office/drawing/2014/main" val="4056267791"/>
                    </a:ext>
                  </a:extLst>
                </a:gridCol>
                <a:gridCol w="6202736">
                  <a:extLst>
                    <a:ext uri="{9D8B030D-6E8A-4147-A177-3AD203B41FA5}">
                      <a16:colId xmlns:a16="http://schemas.microsoft.com/office/drawing/2014/main" val="2102847614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Content of Question</a:t>
                      </a:r>
                      <a:endParaRPr lang="ja-JP" sz="11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Regarding your eating habits over the past four weeks, did the following eating habits apply to you?</a:t>
                      </a:r>
                      <a:endParaRPr lang="ja-JP" sz="11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1991384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Score </a:t>
                      </a:r>
                      <a:endParaRPr lang="ja-JP" sz="11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score1; Not applicable at all, </a:t>
                      </a:r>
                      <a:endParaRPr lang="ja-JP" sz="11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score2; not at all applicable, </a:t>
                      </a:r>
                      <a:endParaRPr lang="ja-JP" sz="11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score3; Somewhat does not apply, </a:t>
                      </a:r>
                      <a:endParaRPr lang="ja-JP" sz="11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score4; Can't say either way, </a:t>
                      </a:r>
                      <a:endParaRPr lang="ja-JP" sz="11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score5; Somewhat applicable, </a:t>
                      </a:r>
                      <a:endParaRPr lang="ja-JP" sz="11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score6; Much more applies, </a:t>
                      </a:r>
                      <a:endParaRPr lang="ja-JP" sz="11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score7; Very much applies at all</a:t>
                      </a:r>
                      <a:endParaRPr lang="ja-JP" sz="11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9845294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effectLst/>
                          <a:highlight>
                            <a:srgbClr val="FFFF00"/>
                          </a:highlight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Eating habits</a:t>
                      </a:r>
                      <a:endParaRPr lang="ja-JP" sz="1100" kern="100" dirty="0">
                        <a:effectLst/>
                        <a:highlight>
                          <a:srgbClr val="FFFF00"/>
                        </a:highlight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Irregular amount; Irregular amounts of breakfast, lunch and dinner on different days,</a:t>
                      </a:r>
                      <a:endParaRPr lang="ja-JP" sz="11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Less chewing; Less chewing</a:t>
                      </a:r>
                      <a:r>
                        <a:rPr lang="en-US" sz="1100" kern="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 during meals</a:t>
                      </a:r>
                      <a:endParaRPr lang="ja-JP" sz="11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Large amount of food; Eating large amount of food per meal,</a:t>
                      </a:r>
                      <a:endParaRPr lang="ja-JP" sz="11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Eating out a lot,</a:t>
                      </a:r>
                      <a:endParaRPr lang="ja-JP" sz="11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Nutritional unbalances,</a:t>
                      </a:r>
                      <a:endParaRPr lang="ja-JP" sz="11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Excessive salt; </a:t>
                      </a:r>
                      <a:r>
                        <a:rPr lang="en-US" sz="1100" kern="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Consume too much salt,</a:t>
                      </a:r>
                      <a:endParaRPr lang="ja-JP" sz="11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67685986"/>
                  </a:ext>
                </a:extLst>
              </a:tr>
            </a:tbl>
          </a:graphicData>
        </a:graphic>
      </p:graphicFrame>
      <p:sp>
        <p:nvSpPr>
          <p:cNvPr id="6" name="Rectangle 1"/>
          <p:cNvSpPr>
            <a:spLocks noChangeArrowheads="1"/>
          </p:cNvSpPr>
          <p:nvPr/>
        </p:nvSpPr>
        <p:spPr bwMode="auto">
          <a:xfrm>
            <a:off x="94747" y="71970"/>
            <a:ext cx="3877985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ja-JP" sz="1100" b="1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l Table S4. </a:t>
            </a:r>
            <a:r>
              <a:rPr kumimoji="0" lang="en-US" altLang="ja-JP" sz="1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ontent of question about Eating habits.</a:t>
            </a: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E0C785D8-F46F-5D6D-F841-A62CDB22B576}"/>
              </a:ext>
            </a:extLst>
          </p:cNvPr>
          <p:cNvSpPr txBox="1"/>
          <p:nvPr/>
        </p:nvSpPr>
        <p:spPr>
          <a:xfrm>
            <a:off x="157480" y="2742244"/>
            <a:ext cx="7271008" cy="369332"/>
          </a:xfrm>
          <a:prstGeom prst="rect">
            <a:avLst/>
          </a:prstGeom>
          <a:solidFill>
            <a:srgbClr val="FFFF00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ating out is not simple, because some restaurants serve nutrition healthy food, but some fast food shop serve</a:t>
            </a:r>
            <a:r>
              <a:rPr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ily junk food. </a:t>
            </a:r>
          </a:p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wever, Japanese people usually understand that eating out means unhealthy food serve.</a:t>
            </a:r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208553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96</TotalTime>
  <Words>171</Words>
  <Application>Microsoft Office PowerPoint</Application>
  <PresentationFormat>Widescreen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游明朝</vt:lpstr>
      <vt:lpstr>Arial</vt:lpstr>
      <vt:lpstr>Times New Roman</vt:lpstr>
      <vt:lpstr>Office テーマ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ibata shigenobu</dc:creator>
  <cp:lastModifiedBy>MDPI</cp:lastModifiedBy>
  <cp:revision>41</cp:revision>
  <cp:lastPrinted>2022-06-15T02:16:55Z</cp:lastPrinted>
  <dcterms:created xsi:type="dcterms:W3CDTF">2021-12-25T05:48:07Z</dcterms:created>
  <dcterms:modified xsi:type="dcterms:W3CDTF">2022-12-06T02:57:52Z</dcterms:modified>
</cp:coreProperties>
</file>